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6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 l="4222" t="14389" r="2304" b="8373"/>
          <a:stretch>
            <a:fillRect/>
          </a:stretch>
        </p:blipFill>
        <p:spPr bwMode="auto">
          <a:xfrm rot="16200000">
            <a:off x="-347156" y="2263987"/>
            <a:ext cx="8172400" cy="42204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260648" y="251520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S4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6672" y="539552"/>
            <a:ext cx="55446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: Gene ontology enrichment analysis of maize genes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ownregulated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by the cluster 19A deletion but not by the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 tin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mutants at 4 dpi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(yellow boxes) that are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19A.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5:03Z</dcterms:modified>
</cp:coreProperties>
</file>